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1" r:id="rId1"/>
  </p:sldMasterIdLst>
  <p:handoutMasterIdLst>
    <p:handoutMasterId r:id="rId4"/>
  </p:handoutMasterIdLst>
  <p:sldIdLst>
    <p:sldId id="276" r:id="rId2"/>
    <p:sldId id="277" r:id="rId3"/>
  </p:sldIdLst>
  <p:sldSz cx="6858000" cy="9144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2502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0CCA6D-885C-46BE-99B6-D7BE0AA3ADCF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B396086-4DF5-4C1A-9383-489DF13016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27858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5288362D-1D0C-4593-A9CA-02F6DE5E30E4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34015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605C50B-E0C3-4BF6-8544-A9C566FA2995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197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543C7264-A86D-4D82-B02E-BD7B43AA2336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9142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ABCC6F7-0F91-4441-BF97-A3AF72A48303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480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92A0F213-BB88-4223-AECB-E7C98DE4F91F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70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05F555C-B798-4584-9735-0D743CA03846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7449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978F460-E66C-4863-AF15-C4A2426FA0FC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6045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722F1AA-6A28-4DC7-B08E-B0B6C8267958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422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B9ED24E-8843-4C3A-ACB3-45594BD874A2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10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5017539-FB6A-4BCE-86F3-A1A36D159024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2004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879D9DB-D59E-4BB7-A5D4-1AE4FF1B3F06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319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8C841DE4-B32F-40E3-9F96-C2C98F208100}" type="datetime1">
              <a:rPr lang="en-US" smtClean="0"/>
              <a:pPr>
                <a:defRPr/>
              </a:pPr>
              <a:t>7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CDB8A7E9-E4BA-4136-A86B-FC9378F0562E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1231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2" r:id="rId1"/>
    <p:sldLayoutId id="2147483723" r:id="rId2"/>
    <p:sldLayoutId id="2147483724" r:id="rId3"/>
    <p:sldLayoutId id="2147483725" r:id="rId4"/>
    <p:sldLayoutId id="2147483726" r:id="rId5"/>
    <p:sldLayoutId id="2147483727" r:id="rId6"/>
    <p:sldLayoutId id="2147483728" r:id="rId7"/>
    <p:sldLayoutId id="2147483729" r:id="rId8"/>
    <p:sldLayoutId id="2147483730" r:id="rId9"/>
    <p:sldLayoutId id="2147483731" r:id="rId10"/>
    <p:sldLayoutId id="2147483732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 txBox="1">
            <a:spLocks/>
          </p:cNvSpPr>
          <p:nvPr/>
        </p:nvSpPr>
        <p:spPr bwMode="auto">
          <a:xfrm>
            <a:off x="-30096" y="8100392"/>
            <a:ext cx="6888096" cy="11125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21920" tIns="60960" rIns="121920" bIns="60960" numCol="1" anchor="ctr" anchorCtr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4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rinciple components analysis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(left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anels) to identify which nutrients are the driving forces in differentiation of experimental groups over 6 experimental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weeks. Right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ide panels present the loadings of the principal components analysis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ll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variables had the same units of measurement (i.e. g/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wk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). Abbreviations: CFI_T: crude fat intake; CPI_T: crude protein intake; </a:t>
            </a:r>
            <a:r>
              <a:rPr lang="en-US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ashI_T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; crude ash intake; C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NDFI_T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; NDF intake; </a:t>
            </a:r>
            <a:r>
              <a:rPr lang="en-US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tarch_T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starch intake. </a:t>
            </a:r>
            <a:endParaRPr lang="de-DE" sz="105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0648" y="0"/>
            <a:ext cx="6120680" cy="82041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26072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2656" y="107504"/>
            <a:ext cx="6007510" cy="8182966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404664" y="8451140"/>
            <a:ext cx="37689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ontinue of 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</a:t>
            </a:r>
            <a:r>
              <a:rPr lang="en-US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4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9983435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2</Words>
  <Application>Microsoft Office PowerPoint</Application>
  <PresentationFormat>On-screen Show (4:3)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Leibniz-Institut für Nutztierbiologie (FBN)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eyedalmossavi, Seyed Mohammadmahdi</dc:creator>
  <cp:lastModifiedBy>Seyedalmoosavi, Seyed Mohammadmahdi</cp:lastModifiedBy>
  <cp:revision>148</cp:revision>
  <cp:lastPrinted>2022-01-18T09:07:24Z</cp:lastPrinted>
  <dcterms:created xsi:type="dcterms:W3CDTF">2021-11-10T16:13:10Z</dcterms:created>
  <dcterms:modified xsi:type="dcterms:W3CDTF">2022-07-13T13:11:41Z</dcterms:modified>
</cp:coreProperties>
</file>